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7.wmf" ContentType="image/x-wmf"/>
  <Override PartName="/ppt/media/image23.wmf" ContentType="image/x-wmf"/>
  <Override PartName="/ppt/media/image22.wmf" ContentType="image/x-wmf"/>
  <Override PartName="/ppt/media/image21.wmf" ContentType="image/x-wmf"/>
  <Override PartName="/ppt/media/image19.wmf" ContentType="image/x-wmf"/>
  <Override PartName="/ppt/media/image20.wmf" ContentType="image/x-wmf"/>
  <Override PartName="/ppt/media/image18.wmf" ContentType="image/x-wmf"/>
  <Override PartName="/ppt/media/image29.wmf" ContentType="image/x-wmf"/>
  <Override PartName="/ppt/media/image11.wmf" ContentType="image/x-wmf"/>
  <Override PartName="/ppt/media/image4.png" ContentType="image/png"/>
  <Override PartName="/ppt/media/image12.wmf" ContentType="image/x-wmf"/>
  <Override PartName="/ppt/media/image6.wmf" ContentType="image/x-wmf"/>
  <Override PartName="/ppt/media/image36.wmf" ContentType="image/x-wmf"/>
  <Override PartName="/ppt/media/image7.wmf" ContentType="image/x-wmf"/>
  <Override PartName="/ppt/media/image8.wmf" ContentType="image/x-wmf"/>
  <Override PartName="/ppt/media/image13.wmf" ContentType="image/x-wmf"/>
  <Override PartName="/ppt/media/image9.wmf" ContentType="image/x-wmf"/>
  <Override PartName="/ppt/media/image34.wmf" ContentType="image/x-wmf"/>
  <Override PartName="/ppt/media/image30.wmf" ContentType="image/x-wmf"/>
  <Override PartName="/ppt/media/image28.wmf" ContentType="image/x-wmf"/>
  <Override PartName="/ppt/media/image10.wmf" ContentType="image/x-wmf"/>
  <Override PartName="/ppt/media/image5.wmf" ContentType="image/x-wmf"/>
  <Override PartName="/ppt/media/image35.wmf" ContentType="image/x-wmf"/>
  <Override PartName="/ppt/media/image33.wmf" ContentType="image/x-wmf"/>
  <Override PartName="/ppt/media/image3.wmf" ContentType="image/x-wmf"/>
  <Override PartName="/ppt/media/image26.wmf" ContentType="image/x-wmf"/>
  <Override PartName="/ppt/media/image32.wmf" ContentType="image/x-wmf"/>
  <Override PartName="/ppt/media/image2.wmf" ContentType="image/x-wmf"/>
  <Override PartName="/ppt/media/image25.wmf" ContentType="image/x-wmf"/>
  <Override PartName="/ppt/media/image31.wmf" ContentType="image/x-wmf"/>
  <Override PartName="/ppt/media/image1.wmf" ContentType="image/x-wmf"/>
  <Override PartName="/ppt/media/image24.wmf" ContentType="image/x-wmf"/>
  <Override PartName="/ppt/media/image14.wmf" ContentType="image/x-wmf"/>
  <Override PartName="/ppt/media/image15.wmf" ContentType="image/x-wmf"/>
  <Override PartName="/ppt/media/image16.wmf" ContentType="image/x-wmf"/>
  <Override PartName="/ppt/media/image17.wmf" ContentType="image/x-wmf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</p:sldIdLst>
  <p:sldSz cx="6858000" cy="9907588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F3584C-AE93-42DA-A4D5-10921DEC8FF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9B46AA-D2F8-4544-B044-BCADE288325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A2381F-967F-4F69-845F-FB75F79593A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DCF353-5DD8-49A9-87E7-CC5ED9107BC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51738C-0E65-4D63-9519-65FDB7F9A9B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B7D3AC-5258-45A4-B4AE-C63EBFCC511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68BF2D-6739-4123-A4EE-D1115ACDB68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1995DE-9DCA-4994-9DF1-A17C2D87919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0CB3F0-7310-4907-89D7-A97C63BD528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D7FDAA-8BD3-4217-9682-025F38573D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929168-940D-48A5-8179-7200AACFA7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E12F39-3918-4745-B8F4-7D48E9E72D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44AA658-CD03-4124-8E65-64203B48E7E3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3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4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5.wmf"/><Relationship Id="rId9" Type="http://schemas.openxmlformats.org/officeDocument/2006/relationships/oleObject" Target="../embeddings/oleObject5.bin"/><Relationship Id="rId10" Type="http://schemas.openxmlformats.org/officeDocument/2006/relationships/image" Target="../media/image6.wmf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7.wmf"/><Relationship Id="rId1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8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9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10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11.wmf"/><Relationship Id="rId9" Type="http://schemas.openxmlformats.org/officeDocument/2006/relationships/oleObject" Target="../embeddings/oleObject5.bin"/><Relationship Id="rId10" Type="http://schemas.openxmlformats.org/officeDocument/2006/relationships/image" Target="../media/image12.wmf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13.wmf"/><Relationship Id="rId1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4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15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16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17.wmf"/><Relationship Id="rId9" Type="http://schemas.openxmlformats.org/officeDocument/2006/relationships/oleObject" Target="../embeddings/oleObject5.bin"/><Relationship Id="rId10" Type="http://schemas.openxmlformats.org/officeDocument/2006/relationships/image" Target="../media/image18.wmf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19.wmf"/><Relationship Id="rId13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0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1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22.wmf"/><Relationship Id="rId7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3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4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25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26.wmf"/><Relationship Id="rId9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7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8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29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30.wmf"/><Relationship Id="rId9" Type="http://schemas.openxmlformats.org/officeDocument/2006/relationships/oleObject" Target="../embeddings/oleObject5.bin"/><Relationship Id="rId10" Type="http://schemas.openxmlformats.org/officeDocument/2006/relationships/image" Target="../media/image31.wmf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32.wmf"/><Relationship Id="rId13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33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34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35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36.wmf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 txBox="1"/>
          <p:nvPr/>
        </p:nvSpPr>
        <p:spPr>
          <a:xfrm>
            <a:off x="307440" y="296640"/>
            <a:ext cx="6172200" cy="8551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lnSpc>
                <a:spcPct val="115000"/>
              </a:lnSpc>
              <a:spcBef>
                <a:spcPts val="300"/>
              </a:spcBef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Supplementary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Informa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15000"/>
              </a:lnSpc>
              <a:spcBef>
                <a:spcPts val="300"/>
              </a:spcBef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15000"/>
              </a:lnSpc>
              <a:spcBef>
                <a:spcPts val="300"/>
              </a:spcBef>
              <a:spcAft>
                <a:spcPts val="1001"/>
              </a:spcAft>
              <a:buClr>
                <a:srgbClr val="000000"/>
              </a:buClr>
              <a:buFont typeface="Symbol" charset="2"/>
              <a:buChar char="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Supplementary Figure S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15000"/>
              </a:lnSpc>
              <a:spcBef>
                <a:spcPts val="300"/>
              </a:spcBef>
              <a:spcAft>
                <a:spcPts val="1001"/>
              </a:spcAft>
              <a:buClr>
                <a:srgbClr val="000000"/>
              </a:buClr>
              <a:buFont typeface="Symbol" charset="2"/>
              <a:buChar char="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Supplementary Figure S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15000"/>
              </a:lnSpc>
              <a:spcBef>
                <a:spcPts val="300"/>
              </a:spcBef>
              <a:spcAft>
                <a:spcPts val="1001"/>
              </a:spcAft>
              <a:buClr>
                <a:srgbClr val="000000"/>
              </a:buClr>
              <a:buFont typeface="Symbol" charset="2"/>
              <a:buChar char="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Supplementary Figure S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15000"/>
              </a:lnSpc>
              <a:spcBef>
                <a:spcPts val="300"/>
              </a:spcBef>
              <a:spcAft>
                <a:spcPts val="1001"/>
              </a:spcAft>
              <a:buClr>
                <a:srgbClr val="000000"/>
              </a:buClr>
              <a:buFont typeface="Symbol" charset="2"/>
              <a:buChar char="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Supplementary Figure S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15000"/>
              </a:lnSpc>
              <a:spcBef>
                <a:spcPts val="300"/>
              </a:spcBef>
              <a:spcAft>
                <a:spcPts val="1001"/>
              </a:spcAft>
              <a:buClr>
                <a:srgbClr val="000000"/>
              </a:buClr>
              <a:buFont typeface="Symbol" charset="2"/>
              <a:buChar char="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Supplementary Figure S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15000"/>
              </a:lnSpc>
              <a:spcBef>
                <a:spcPts val="300"/>
              </a:spcBef>
              <a:spcAft>
                <a:spcPts val="1001"/>
              </a:spcAft>
              <a:buClr>
                <a:srgbClr val="000000"/>
              </a:buClr>
              <a:buFont typeface="Symbol" charset="2"/>
              <a:buChar char="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Supplementary Figure S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15000"/>
              </a:lnSpc>
              <a:spcBef>
                <a:spcPts val="300"/>
              </a:spcBef>
              <a:spcAft>
                <a:spcPts val="1001"/>
              </a:spcAft>
              <a:buClr>
                <a:srgbClr val="000000"/>
              </a:buClr>
              <a:buFont typeface="Symbol" charset="2"/>
              <a:buChar char="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Supplementary Figure S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15000"/>
              </a:lnSpc>
              <a:spcBef>
                <a:spcPts val="300"/>
              </a:spcBef>
              <a:spcAft>
                <a:spcPts val="1001"/>
              </a:spcAft>
              <a:buClr>
                <a:srgbClr val="000000"/>
              </a:buClr>
              <a:buFont typeface="Symbol" charset="2"/>
              <a:buChar char="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Supplementary Figure S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" name="Picture 22" descr=""/>
          <p:cNvPicPr/>
          <p:nvPr/>
        </p:nvPicPr>
        <p:blipFill>
          <a:blip r:embed="rId1"/>
          <a:stretch/>
        </p:blipFill>
        <p:spPr>
          <a:xfrm>
            <a:off x="228600" y="181080"/>
            <a:ext cx="6305400" cy="8624880"/>
          </a:xfrm>
          <a:prstGeom prst="rect">
            <a:avLst/>
          </a:prstGeom>
          <a:ln w="0">
            <a:noFill/>
          </a:ln>
        </p:spPr>
      </p:pic>
      <p:sp>
        <p:nvSpPr>
          <p:cNvPr id="43" name="Text Box 12"/>
          <p:cNvSpPr/>
          <p:nvPr/>
        </p:nvSpPr>
        <p:spPr>
          <a:xfrm>
            <a:off x="0" y="8871120"/>
            <a:ext cx="66978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1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low-chart to illustrate the progression of work during the current study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4" name="Object 12"/>
          <p:cNvGraphicFramePr/>
          <p:nvPr/>
        </p:nvGraphicFramePr>
        <p:xfrm>
          <a:off x="139680" y="2544840"/>
          <a:ext cx="3422520" cy="22302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5" name="Object 1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39680" y="2544840"/>
                    <a:ext cx="3422520" cy="2230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6" name="Object 13"/>
          <p:cNvGraphicFramePr/>
          <p:nvPr/>
        </p:nvGraphicFramePr>
        <p:xfrm>
          <a:off x="144360" y="181080"/>
          <a:ext cx="3417840" cy="223344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47" name="Object 13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44360" y="181080"/>
                    <a:ext cx="3417840" cy="2233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8" name="Object 6"/>
          <p:cNvGraphicFramePr/>
          <p:nvPr/>
        </p:nvGraphicFramePr>
        <p:xfrm>
          <a:off x="3141720" y="168120"/>
          <a:ext cx="3666960" cy="244188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49" name="Object 6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3141720" y="168120"/>
                    <a:ext cx="3666960" cy="24418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0" name="Object 11"/>
          <p:cNvGraphicFramePr/>
          <p:nvPr/>
        </p:nvGraphicFramePr>
        <p:xfrm>
          <a:off x="111240" y="4876920"/>
          <a:ext cx="3774960" cy="267012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51" name="Object 11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111240" y="4876920"/>
                    <a:ext cx="3774960" cy="2670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2" name="Object 4"/>
          <p:cNvGraphicFramePr/>
          <p:nvPr/>
        </p:nvGraphicFramePr>
        <p:xfrm>
          <a:off x="3567240" y="4890960"/>
          <a:ext cx="3375000" cy="267048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53" name="Object 4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3567240" y="4890960"/>
                    <a:ext cx="3375000" cy="2670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4" name="Object 5"/>
          <p:cNvGraphicFramePr/>
          <p:nvPr/>
        </p:nvGraphicFramePr>
        <p:xfrm>
          <a:off x="3673440" y="2494080"/>
          <a:ext cx="2932200" cy="223020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55" name="Object 5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3673440" y="2494080"/>
                    <a:ext cx="2932200" cy="2230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6" name="Text Box 8"/>
          <p:cNvSpPr/>
          <p:nvPr/>
        </p:nvSpPr>
        <p:spPr>
          <a:xfrm>
            <a:off x="1957320" y="317520"/>
            <a:ext cx="285840" cy="28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 Box 9"/>
          <p:cNvSpPr/>
          <p:nvPr/>
        </p:nvSpPr>
        <p:spPr>
          <a:xfrm>
            <a:off x="3000240" y="5165640"/>
            <a:ext cx="285840" cy="28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 Box 10"/>
          <p:cNvSpPr/>
          <p:nvPr/>
        </p:nvSpPr>
        <p:spPr>
          <a:xfrm>
            <a:off x="2962440" y="2690640"/>
            <a:ext cx="285480" cy="28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 Box 15"/>
          <p:cNvSpPr/>
          <p:nvPr/>
        </p:nvSpPr>
        <p:spPr>
          <a:xfrm>
            <a:off x="6022800" y="2711520"/>
            <a:ext cx="284400" cy="28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 Box 16"/>
          <p:cNvSpPr/>
          <p:nvPr/>
        </p:nvSpPr>
        <p:spPr>
          <a:xfrm>
            <a:off x="6031080" y="5138640"/>
            <a:ext cx="284040" cy="28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 Box 18"/>
          <p:cNvSpPr/>
          <p:nvPr/>
        </p:nvSpPr>
        <p:spPr>
          <a:xfrm>
            <a:off x="58680" y="7539120"/>
            <a:ext cx="6686640" cy="1950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 fontScale="92000"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2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Interactions between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. sambucinum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nd biocontrol agents on (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-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c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 NA and (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-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 PDA: (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and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 radial extension of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. sambucinum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on the side adjacent to the biocontrol agent (dotted lines indicate the distance between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. sambucinum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and biocontrol agent at the time of inoculation; (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and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 extent of colony of biocontrol agent beyond the initial zone-of-inoculation (over time), on the side adjacent to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. sambucinum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; and (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and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 distance between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ambucinum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and biocontrol agent over time. NA control (no biocontrol agent; </a:t>
            </a:r>
            <a:r>
              <a:rPr b="0" lang="en-US" sz="1200" spc="-1" strike="noStrike">
                <a:solidFill>
                  <a:srgbClr val="000000"/>
                </a:solidFill>
                <a:latin typeface="Wingdings 2"/>
                <a:ea typeface="Wingdings 2"/>
              </a:rPr>
              <a:t>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, PDA control (no biocontrol agent; </a:t>
            </a:r>
            <a:r>
              <a:rPr b="0" lang="en-US" sz="1200" spc="-1" strike="noStrike">
                <a:solidFill>
                  <a:srgbClr val="000000"/>
                </a:solidFill>
                <a:latin typeface="Wingdings 2"/>
                <a:ea typeface="Wingdings 2"/>
              </a:rPr>
              <a:t>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, JC12GB34 (</a:t>
            </a:r>
            <a:r>
              <a:rPr b="0" lang="en-US" sz="1200" spc="-1" strike="noStrike">
                <a:solidFill>
                  <a:srgbClr val="000000"/>
                </a:solidFill>
                <a:latin typeface="Wingdings 2"/>
                <a:ea typeface="Wingdings 2"/>
              </a:rPr>
              <a:t>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, JC12GB43 (</a:t>
            </a:r>
            <a:r>
              <a:rPr b="0" lang="en-US" sz="1200" spc="-1" strike="noStrike">
                <a:solidFill>
                  <a:srgbClr val="000000"/>
                </a:solidFill>
                <a:latin typeface="Wingdings 2"/>
                <a:ea typeface="Wingdings 2"/>
              </a:rPr>
              <a:t>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, JC12GB54 (</a:t>
            </a:r>
            <a:r>
              <a:rPr b="0" lang="en-US" sz="1200" spc="-1" strike="noStrike">
                <a:solidFill>
                  <a:srgbClr val="ff0000"/>
                </a:solidFill>
                <a:latin typeface="Wingdings 2"/>
                <a:ea typeface="Wingdings 2"/>
              </a:rPr>
              <a:t>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, JC12GB78 (</a:t>
            </a:r>
            <a:r>
              <a:rPr b="0" lang="en-US" sz="1200" spc="-1" strike="noStrike">
                <a:solidFill>
                  <a:srgbClr val="000000"/>
                </a:solidFill>
                <a:latin typeface="Wingdings 3"/>
                <a:ea typeface="Wingdings 3"/>
              </a:rPr>
              <a:t>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, JC12GB70 (</a:t>
            </a:r>
            <a:r>
              <a:rPr b="0" lang="en-US" sz="1200" spc="-1" strike="noStrike">
                <a:solidFill>
                  <a:srgbClr val="000000"/>
                </a:solidFill>
                <a:latin typeface="Wingdings 3"/>
                <a:ea typeface="Wingdings 3"/>
              </a:rPr>
              <a:t>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, JC12GB80 (</a:t>
            </a:r>
            <a:r>
              <a:rPr b="0" lang="en-US" sz="1200" spc="-1" strike="noStrike">
                <a:solidFill>
                  <a:srgbClr val="000000"/>
                </a:solidFill>
                <a:latin typeface="Wingdings 2"/>
                <a:ea typeface="Wingdings 2"/>
              </a:rPr>
              <a:t>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, JC12GB75 (</a:t>
            </a:r>
            <a:r>
              <a:rPr b="0" lang="en-US" sz="1200" spc="-1" strike="noStrike">
                <a:solidFill>
                  <a:srgbClr val="000000"/>
                </a:solidFill>
                <a:latin typeface="Wingdings 2"/>
                <a:ea typeface="Wingdings 2"/>
              </a:rPr>
              <a:t>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, JC12GB73 (</a:t>
            </a:r>
            <a:r>
              <a:rPr b="0" lang="en-US" sz="1200" spc="-1" strike="noStrike">
                <a:solidFill>
                  <a:srgbClr val="000000"/>
                </a:solidFill>
                <a:latin typeface="Wingdings 2"/>
                <a:ea typeface="Wingdings 2"/>
              </a:rPr>
              <a:t>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, JC12GB58 (</a:t>
            </a:r>
            <a:r>
              <a:rPr b="0" lang="en-US" sz="1200" spc="-1" strike="noStrike">
                <a:solidFill>
                  <a:srgbClr val="000000"/>
                </a:solidFill>
                <a:latin typeface="Wingdings 3"/>
                <a:ea typeface="Wingdings 3"/>
              </a:rPr>
              <a:t>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, JC12GB64 (</a:t>
            </a:r>
            <a:r>
              <a:rPr b="0" lang="en-US" sz="1200" spc="-1" strike="noStrike">
                <a:solidFill>
                  <a:srgbClr val="ff0000"/>
                </a:solidFill>
                <a:latin typeface="Arial"/>
                <a:ea typeface="Arial"/>
              </a:rPr>
              <a:t>I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, JC12GB65 (</a:t>
            </a:r>
            <a:r>
              <a:rPr b="0" lang="en-US" sz="1200" spc="-1" strike="noStrike">
                <a:solidFill>
                  <a:srgbClr val="ff0000"/>
                </a:solidFill>
                <a:latin typeface="Wingdings 3"/>
                <a:ea typeface="Wingdings 3"/>
              </a:rPr>
              <a:t>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,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acillus subtilis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QST-713 (</a:t>
            </a:r>
            <a:r>
              <a:rPr b="0" lang="en-US" sz="1200" spc="-1" strike="noStrike">
                <a:solidFill>
                  <a:srgbClr val="000000"/>
                </a:solidFill>
                <a:latin typeface="Wingdings 2"/>
                <a:ea typeface="Wingdings 2"/>
              </a:rPr>
              <a:t>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,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antoea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p. S09:T:12 (</a:t>
            </a:r>
            <a:r>
              <a:rPr b="0" lang="en-US" sz="1200" spc="-1" strike="noStrike">
                <a:solidFill>
                  <a:srgbClr val="000000"/>
                </a:solidFill>
                <a:latin typeface="Wingdings 2"/>
                <a:ea typeface="Wingdings 2"/>
              </a:rPr>
              <a:t>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,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seudomonas fluorescens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-79 (</a:t>
            </a:r>
            <a:r>
              <a:rPr b="0" lang="en-US" sz="1200" spc="-1" strike="noStrike">
                <a:solidFill>
                  <a:srgbClr val="000000"/>
                </a:solidFill>
                <a:latin typeface="Wingdings 2"/>
                <a:ea typeface="Wingdings 2"/>
              </a:rPr>
              <a:t>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,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treptomyces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p. NC-1487 (</a:t>
            </a:r>
            <a:r>
              <a:rPr b="0" lang="en-US" sz="1200" spc="-1" strike="noStrike">
                <a:solidFill>
                  <a:srgbClr val="000000"/>
                </a:solidFill>
                <a:latin typeface="Wingdings 3"/>
                <a:ea typeface="Wingdings 3"/>
              </a:rPr>
              <a:t>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,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ichia anomala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J121 (</a:t>
            </a:r>
            <a:r>
              <a:rPr b="0" lang="en-US" sz="1200" spc="-1" strike="noStrike">
                <a:solidFill>
                  <a:srgbClr val="000000"/>
                </a:solidFill>
                <a:latin typeface="Wingdings 2"/>
                <a:ea typeface="Wingdings 2"/>
              </a:rPr>
              <a:t>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. Upon inoculation of NA and PDA,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. sambucinum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and the biocontrol agents were placed 40-mm apart. Error bars indicate ± standard error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 Box 14"/>
          <p:cNvSpPr/>
          <p:nvPr/>
        </p:nvSpPr>
        <p:spPr>
          <a:xfrm>
            <a:off x="6021360" y="387360"/>
            <a:ext cx="284040" cy="28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 Box 14"/>
          <p:cNvSpPr/>
          <p:nvPr/>
        </p:nvSpPr>
        <p:spPr>
          <a:xfrm>
            <a:off x="2952720" y="366840"/>
            <a:ext cx="28404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4" name="Object 20"/>
          <p:cNvGraphicFramePr/>
          <p:nvPr/>
        </p:nvGraphicFramePr>
        <p:xfrm>
          <a:off x="3549600" y="185760"/>
          <a:ext cx="3165480" cy="237816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65" name="Object 20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549600" y="185760"/>
                    <a:ext cx="3165480" cy="2378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6" name="Object 18"/>
          <p:cNvGraphicFramePr/>
          <p:nvPr/>
        </p:nvGraphicFramePr>
        <p:xfrm>
          <a:off x="600120" y="176040"/>
          <a:ext cx="3174840" cy="240840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67" name="Object 18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600120" y="176040"/>
                    <a:ext cx="3174840" cy="2408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8" name="Rectangle 5"/>
          <p:cNvSpPr/>
          <p:nvPr/>
        </p:nvSpPr>
        <p:spPr>
          <a:xfrm>
            <a:off x="0" y="3435480"/>
            <a:ext cx="184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69" name="Object 4"/>
          <p:cNvGraphicFramePr/>
          <p:nvPr/>
        </p:nvGraphicFramePr>
        <p:xfrm>
          <a:off x="587520" y="4518000"/>
          <a:ext cx="3176280" cy="269100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70" name="Object 4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587520" y="4518000"/>
                    <a:ext cx="3176280" cy="2691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71" name="Rectangle 7"/>
          <p:cNvSpPr/>
          <p:nvPr/>
        </p:nvSpPr>
        <p:spPr>
          <a:xfrm>
            <a:off x="0" y="3402000"/>
            <a:ext cx="184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72" name="Object 6"/>
          <p:cNvGraphicFramePr/>
          <p:nvPr/>
        </p:nvGraphicFramePr>
        <p:xfrm>
          <a:off x="3591000" y="4562640"/>
          <a:ext cx="3166920" cy="266220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73" name="Object 6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3591000" y="4562640"/>
                    <a:ext cx="3166920" cy="2662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74" name="Rectangle 9"/>
          <p:cNvSpPr/>
          <p:nvPr/>
        </p:nvSpPr>
        <p:spPr>
          <a:xfrm>
            <a:off x="0" y="3564000"/>
            <a:ext cx="184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75" name="Object 8"/>
          <p:cNvGraphicFramePr/>
          <p:nvPr/>
        </p:nvGraphicFramePr>
        <p:xfrm>
          <a:off x="706320" y="2297160"/>
          <a:ext cx="2732040" cy="223056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76" name="Object 8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706320" y="2297160"/>
                    <a:ext cx="2732040" cy="2230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77" name="Rectangle 11"/>
          <p:cNvSpPr/>
          <p:nvPr/>
        </p:nvSpPr>
        <p:spPr>
          <a:xfrm>
            <a:off x="0" y="3564000"/>
            <a:ext cx="184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78" name="Object 10"/>
          <p:cNvGraphicFramePr/>
          <p:nvPr/>
        </p:nvGraphicFramePr>
        <p:xfrm>
          <a:off x="3686040" y="2295360"/>
          <a:ext cx="2733840" cy="223056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79" name="Object 10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3686040" y="2295360"/>
                    <a:ext cx="2733840" cy="2230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0" name="Text Box 12"/>
          <p:cNvSpPr/>
          <p:nvPr/>
        </p:nvSpPr>
        <p:spPr>
          <a:xfrm>
            <a:off x="1604880" y="368280"/>
            <a:ext cx="285840" cy="28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 Box 13"/>
          <p:cNvSpPr/>
          <p:nvPr/>
        </p:nvSpPr>
        <p:spPr>
          <a:xfrm>
            <a:off x="1614600" y="4741920"/>
            <a:ext cx="285480" cy="28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Text Box 14"/>
          <p:cNvSpPr/>
          <p:nvPr/>
        </p:nvSpPr>
        <p:spPr>
          <a:xfrm>
            <a:off x="1606680" y="2517840"/>
            <a:ext cx="285480" cy="28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Text Box 15"/>
          <p:cNvSpPr/>
          <p:nvPr/>
        </p:nvSpPr>
        <p:spPr>
          <a:xfrm>
            <a:off x="4654440" y="387360"/>
            <a:ext cx="284400" cy="28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Text Box 16"/>
          <p:cNvSpPr/>
          <p:nvPr/>
        </p:nvSpPr>
        <p:spPr>
          <a:xfrm>
            <a:off x="4659480" y="2475000"/>
            <a:ext cx="284040" cy="28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Text Box 17"/>
          <p:cNvSpPr/>
          <p:nvPr/>
        </p:nvSpPr>
        <p:spPr>
          <a:xfrm>
            <a:off x="4657680" y="4735440"/>
            <a:ext cx="284040" cy="28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Rectangle 19"/>
          <p:cNvSpPr/>
          <p:nvPr/>
        </p:nvSpPr>
        <p:spPr>
          <a:xfrm>
            <a:off x="0" y="3435480"/>
            <a:ext cx="184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Rectangle 21"/>
          <p:cNvSpPr/>
          <p:nvPr/>
        </p:nvSpPr>
        <p:spPr>
          <a:xfrm>
            <a:off x="0" y="3454560"/>
            <a:ext cx="184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Text Box 30"/>
          <p:cNvSpPr/>
          <p:nvPr/>
        </p:nvSpPr>
        <p:spPr>
          <a:xfrm>
            <a:off x="95400" y="7362720"/>
            <a:ext cx="6708600" cy="2127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3.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Interactions between biocontrol agents and (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a - c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P. infestans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isolates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0LD3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or (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d - f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0D2_5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on CA: (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and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 radial extension of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P. infestans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on the side adjacent to the biocontrol agent (dotted lines indicate the distance between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P. infestans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and biocontrol agent at the time of inoculation; (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and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 extent of colony of biocontrol agent beyond the initial zone-of-inoculation (over time), on the side adjacent to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P. infestans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; and (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and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; distance between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P. infestans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and biocontrol agent over time.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Phytophthora infestans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0LD3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control (</a:t>
            </a:r>
            <a:r>
              <a:rPr b="0" lang="en-GB" sz="1200" spc="-1" strike="noStrike">
                <a:solidFill>
                  <a:srgbClr val="000000"/>
                </a:solidFill>
                <a:latin typeface="Wingdings 2"/>
                <a:ea typeface="Wingdings 2"/>
              </a:rPr>
              <a:t>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,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Phytophthora infestans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0D2_5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control (</a:t>
            </a:r>
            <a:r>
              <a:rPr b="0" lang="en-GB" sz="1200" spc="-1" strike="noStrike">
                <a:solidFill>
                  <a:srgbClr val="000000"/>
                </a:solidFill>
                <a:latin typeface="Wingdings 2"/>
                <a:ea typeface="Wingdings 2"/>
              </a:rPr>
              <a:t>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, JC12GB34 (</a:t>
            </a:r>
            <a:r>
              <a:rPr b="0" lang="en-US" sz="1200" spc="-1" strike="noStrike">
                <a:solidFill>
                  <a:srgbClr val="000000"/>
                </a:solidFill>
                <a:latin typeface="Wingdings 2"/>
                <a:ea typeface="Wingdings 2"/>
              </a:rPr>
              <a:t>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, JC12GB43 (</a:t>
            </a:r>
            <a:r>
              <a:rPr b="0" lang="en-US" sz="1200" spc="-1" strike="noStrike">
                <a:solidFill>
                  <a:srgbClr val="000000"/>
                </a:solidFill>
                <a:latin typeface="Wingdings 2"/>
                <a:ea typeface="Wingdings 2"/>
              </a:rPr>
              <a:t>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, 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Bacillus subtilis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QST-713 (</a:t>
            </a:r>
            <a:r>
              <a:rPr b="0" lang="en-US" sz="1200" spc="-1" strike="noStrike">
                <a:solidFill>
                  <a:srgbClr val="000000"/>
                </a:solidFill>
                <a:latin typeface="Wingdings 2"/>
                <a:ea typeface="Wingdings 2"/>
              </a:rPr>
              <a:t>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,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Pantoea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sp. S09:T:12 (</a:t>
            </a:r>
            <a:r>
              <a:rPr b="0" lang="en-US" sz="1200" spc="-1" strike="noStrike">
                <a:solidFill>
                  <a:srgbClr val="000000"/>
                </a:solidFill>
                <a:latin typeface="Wingdings 2"/>
                <a:ea typeface="Wingdings 2"/>
              </a:rPr>
              <a:t>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,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Pseudomonas fluorescens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2-79 (</a:t>
            </a:r>
            <a:r>
              <a:rPr b="0" lang="en-US" sz="1200" spc="-1" strike="noStrike">
                <a:solidFill>
                  <a:srgbClr val="000000"/>
                </a:solidFill>
                <a:latin typeface="Wingdings 2"/>
                <a:ea typeface="Wingdings 2"/>
              </a:rPr>
              <a:t>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,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Streptomyces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sp. NC-1487 (</a:t>
            </a:r>
            <a:r>
              <a:rPr b="0" lang="en-US" sz="1200" spc="-1" strike="noStrike">
                <a:solidFill>
                  <a:srgbClr val="000000"/>
                </a:solidFill>
                <a:latin typeface="Wingdings 3"/>
                <a:ea typeface="Wingdings 3"/>
              </a:rPr>
              <a:t>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,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Pichia anomala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J121 (</a:t>
            </a:r>
            <a:r>
              <a:rPr b="0" lang="en-US" sz="1200" spc="-1" strike="noStrike">
                <a:solidFill>
                  <a:srgbClr val="000000"/>
                </a:solidFill>
                <a:latin typeface="Wingdings 2"/>
                <a:ea typeface="Wingdings 2"/>
              </a:rPr>
              <a:t>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. Upon inoculation of CA,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P. infestans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0LD3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and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0D2_5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were placed 25- and 16-mm apart from the biocontrol agents, respectively. Error bars indicate ± standard error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TextBox 1"/>
          <p:cNvSpPr/>
          <p:nvPr/>
        </p:nvSpPr>
        <p:spPr>
          <a:xfrm rot="16200000">
            <a:off x="-547200" y="5525640"/>
            <a:ext cx="215244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Distance between </a:t>
            </a:r>
            <a:r>
              <a:rPr b="0" i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P. infestans 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and the biocontrol agent (mm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TextBox 17"/>
          <p:cNvSpPr/>
          <p:nvPr/>
        </p:nvSpPr>
        <p:spPr>
          <a:xfrm rot="16200000">
            <a:off x="-615600" y="3215880"/>
            <a:ext cx="228600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Extent of biocontrol-agent colony beyond site of inoculation (mm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TextBox 17"/>
          <p:cNvSpPr/>
          <p:nvPr/>
        </p:nvSpPr>
        <p:spPr>
          <a:xfrm rot="16200000">
            <a:off x="-205920" y="1077480"/>
            <a:ext cx="146700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Radial extension of </a:t>
            </a:r>
            <a:r>
              <a:rPr b="0" i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P. infestans 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(mm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2" name="Object 8"/>
          <p:cNvGraphicFramePr/>
          <p:nvPr/>
        </p:nvGraphicFramePr>
        <p:xfrm>
          <a:off x="420840" y="2435400"/>
          <a:ext cx="3268440" cy="22572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93" name="Object 8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20840" y="2435400"/>
                    <a:ext cx="3268440" cy="2257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94" name="Object 14"/>
          <p:cNvGraphicFramePr/>
          <p:nvPr/>
        </p:nvGraphicFramePr>
        <p:xfrm>
          <a:off x="3662280" y="189000"/>
          <a:ext cx="2733840" cy="223020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95" name="Object 14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662280" y="189000"/>
                    <a:ext cx="2733840" cy="2230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96" name="Rectangle 5"/>
          <p:cNvSpPr/>
          <p:nvPr/>
        </p:nvSpPr>
        <p:spPr>
          <a:xfrm>
            <a:off x="0" y="361944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97" name="Object 4"/>
          <p:cNvGraphicFramePr/>
          <p:nvPr/>
        </p:nvGraphicFramePr>
        <p:xfrm>
          <a:off x="430200" y="4665600"/>
          <a:ext cx="3597120" cy="266724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98" name="Object 4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430200" y="4665600"/>
                    <a:ext cx="3597120" cy="26672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99" name="Rectangle 7"/>
          <p:cNvSpPr/>
          <p:nvPr/>
        </p:nvSpPr>
        <p:spPr>
          <a:xfrm>
            <a:off x="0" y="358632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00" name="Object 6"/>
          <p:cNvGraphicFramePr/>
          <p:nvPr/>
        </p:nvGraphicFramePr>
        <p:xfrm>
          <a:off x="3560760" y="4659480"/>
          <a:ext cx="3171960" cy="266220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101" name="Object 6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3560760" y="4659480"/>
                    <a:ext cx="3171960" cy="2662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02" name="Rectangle 9"/>
          <p:cNvSpPr/>
          <p:nvPr/>
        </p:nvSpPr>
        <p:spPr>
          <a:xfrm>
            <a:off x="0" y="374796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Rectangle 11"/>
          <p:cNvSpPr/>
          <p:nvPr/>
        </p:nvSpPr>
        <p:spPr>
          <a:xfrm>
            <a:off x="0" y="374796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04" name="Object 10"/>
          <p:cNvGraphicFramePr/>
          <p:nvPr/>
        </p:nvGraphicFramePr>
        <p:xfrm>
          <a:off x="3651120" y="2398680"/>
          <a:ext cx="2738520" cy="223056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105" name="Object 10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3651120" y="2398680"/>
                    <a:ext cx="2738520" cy="2230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06" name="Rectangle 13"/>
          <p:cNvSpPr/>
          <p:nvPr/>
        </p:nvSpPr>
        <p:spPr>
          <a:xfrm>
            <a:off x="0" y="365760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07" name="Object 12"/>
          <p:cNvGraphicFramePr/>
          <p:nvPr/>
        </p:nvGraphicFramePr>
        <p:xfrm>
          <a:off x="428760" y="210960"/>
          <a:ext cx="3235320" cy="223056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108" name="Object 12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428760" y="210960"/>
                    <a:ext cx="3235320" cy="2230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09" name="Rectangle 15"/>
          <p:cNvSpPr/>
          <p:nvPr/>
        </p:nvSpPr>
        <p:spPr>
          <a:xfrm>
            <a:off x="0" y="365760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Text Box 18"/>
          <p:cNvSpPr/>
          <p:nvPr/>
        </p:nvSpPr>
        <p:spPr>
          <a:xfrm>
            <a:off x="58680" y="7421400"/>
            <a:ext cx="6697800" cy="2101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4.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Interactions between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P. infestans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isolates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0LD3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(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a - c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 or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0D2_5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(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d - f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 and biocontrol agents on CA: (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and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 radial extension of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P. infestans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on the side adjacent to the biocontrol agent (dotted lines indicate the distance between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P. infestans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and biocontrol agent at the time of inoculation; (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and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; extent of colony of biocontrol agent beyond the initial zone-of-inoculation (over time), on the side adjacent to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P. infestans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; and (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and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; distance between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P. infestans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and biocontrol agent over time.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Phytophthora infestans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0LD3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control (</a:t>
            </a:r>
            <a:r>
              <a:rPr b="0" lang="en-GB" sz="1200" spc="-1" strike="noStrike">
                <a:solidFill>
                  <a:srgbClr val="000000"/>
                </a:solidFill>
                <a:latin typeface="Wingdings 2"/>
                <a:ea typeface="Wingdings 2"/>
              </a:rPr>
              <a:t>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,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Phytophthora infestans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0D2_5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control (</a:t>
            </a:r>
            <a:r>
              <a:rPr b="0" lang="en-GB" sz="1200" spc="-1" strike="noStrike">
                <a:solidFill>
                  <a:srgbClr val="000000"/>
                </a:solidFill>
                <a:latin typeface="Wingdings 2"/>
                <a:ea typeface="Wingdings 2"/>
              </a:rPr>
              <a:t>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, JC12GB51 (</a:t>
            </a:r>
            <a:r>
              <a:rPr b="0" lang="en-US" sz="1200" spc="-1" strike="noStrike">
                <a:solidFill>
                  <a:srgbClr val="000000"/>
                </a:solidFill>
                <a:latin typeface="Wingdings 2"/>
                <a:ea typeface="Wingdings 2"/>
              </a:rPr>
              <a:t>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, JC12GB50 (</a:t>
            </a:r>
            <a:r>
              <a:rPr b="0" lang="en-GB" sz="1200" spc="-1" strike="noStrike">
                <a:solidFill>
                  <a:srgbClr val="000000"/>
                </a:solidFill>
                <a:latin typeface="Wingdings 3"/>
                <a:ea typeface="Wingdings 3"/>
              </a:rPr>
              <a:t>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, JC12GB48 (</a:t>
            </a:r>
            <a:r>
              <a:rPr b="0" lang="en-GB" sz="1200" spc="-1" strike="noStrike">
                <a:solidFill>
                  <a:srgbClr val="000000"/>
                </a:solidFill>
                <a:latin typeface="Wingdings 3"/>
                <a:ea typeface="Wingdings 3"/>
              </a:rPr>
              <a:t>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, JC12GB47 (</a:t>
            </a:r>
            <a:r>
              <a:rPr b="0" lang="en-GB" sz="1200" spc="-1" strike="noStrike">
                <a:solidFill>
                  <a:srgbClr val="000000"/>
                </a:solidFill>
                <a:latin typeface="Wingdings 2"/>
                <a:ea typeface="Wingdings 2"/>
              </a:rPr>
              <a:t>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, JC12GB36 (</a:t>
            </a:r>
            <a:r>
              <a:rPr b="0" lang="en-US" sz="1200" spc="-1" strike="noStrike">
                <a:solidFill>
                  <a:srgbClr val="000000"/>
                </a:solidFill>
                <a:latin typeface="Wingdings 2"/>
                <a:ea typeface="Wingdings 2"/>
              </a:rPr>
              <a:t>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, JC12GB35 (</a:t>
            </a:r>
            <a:r>
              <a:rPr b="0" lang="en-US" sz="1200" spc="-1" strike="noStrike">
                <a:solidFill>
                  <a:srgbClr val="ff0000"/>
                </a:solidFill>
                <a:latin typeface="Wingdings 2"/>
                <a:ea typeface="Wingdings 2"/>
              </a:rPr>
              <a:t>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, JC12GB12 (</a:t>
            </a:r>
            <a:r>
              <a:rPr b="0" lang="en-US" sz="1200" spc="-1" strike="noStrike">
                <a:solidFill>
                  <a:srgbClr val="000000"/>
                </a:solidFill>
                <a:latin typeface="Wingdings 2"/>
                <a:ea typeface="Wingdings 2"/>
              </a:rPr>
              <a:t>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, JC12GB13 (</a:t>
            </a:r>
            <a:r>
              <a:rPr b="0" lang="en-US" sz="1200" spc="-1" strike="noStrike">
                <a:solidFill>
                  <a:srgbClr val="000000"/>
                </a:solidFill>
                <a:latin typeface="Wingdings 3"/>
                <a:ea typeface="Wingdings 3"/>
              </a:rPr>
              <a:t>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, JC12GB12 (</a:t>
            </a:r>
            <a:r>
              <a:rPr b="0" lang="en-US" sz="1200" spc="-1" strike="noStrike">
                <a:solidFill>
                  <a:srgbClr val="000000"/>
                </a:solidFill>
                <a:latin typeface="Wingdings 2"/>
                <a:ea typeface="Wingdings 2"/>
              </a:rPr>
              <a:t>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, JC12GB7 (</a:t>
            </a:r>
            <a:r>
              <a:rPr b="0" lang="en-GB" sz="1200" spc="-1" strike="noStrike">
                <a:solidFill>
                  <a:srgbClr val="000000"/>
                </a:solidFill>
                <a:latin typeface="Wingdings 2"/>
                <a:ea typeface="Wingdings 2"/>
              </a:rPr>
              <a:t>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, JC12GB6 (</a:t>
            </a:r>
            <a:r>
              <a:rPr b="0" lang="en-GB" sz="1200" spc="-1" strike="noStrike">
                <a:solidFill>
                  <a:srgbClr val="000000"/>
                </a:solidFill>
                <a:latin typeface="Wingdings 2"/>
                <a:ea typeface="Wingdings 2"/>
              </a:rPr>
              <a:t>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, JC12GB29 (</a:t>
            </a:r>
            <a:r>
              <a:rPr b="0" lang="en-GB" sz="1200" spc="-1" strike="noStrike">
                <a:solidFill>
                  <a:srgbClr val="000000"/>
                </a:solidFill>
                <a:latin typeface="Wingdings 2"/>
                <a:ea typeface="Wingdings 2"/>
              </a:rPr>
              <a:t>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, JC12GB28 (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–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: I;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–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: </a:t>
            </a:r>
            <a:r>
              <a:rPr b="0" lang="en-GB" sz="1200" spc="-1" strike="noStrike">
                <a:solidFill>
                  <a:srgbClr val="ff0000"/>
                </a:solidFill>
                <a:latin typeface="Arial"/>
                <a:ea typeface="Arial"/>
              </a:rPr>
              <a:t>I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. Upon inoculation of CA,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P. infestans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0LD3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and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0D2_5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were placed 25- and 16-mm apart from the biocontrol agents, respectively. Error bars indicate ± standard error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Text Box 12"/>
          <p:cNvSpPr/>
          <p:nvPr/>
        </p:nvSpPr>
        <p:spPr>
          <a:xfrm>
            <a:off x="1790640" y="419040"/>
            <a:ext cx="285840" cy="28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Text Box 13"/>
          <p:cNvSpPr/>
          <p:nvPr/>
        </p:nvSpPr>
        <p:spPr>
          <a:xfrm>
            <a:off x="1770120" y="4884840"/>
            <a:ext cx="28584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Text Box 14"/>
          <p:cNvSpPr/>
          <p:nvPr/>
        </p:nvSpPr>
        <p:spPr>
          <a:xfrm>
            <a:off x="1782720" y="2660760"/>
            <a:ext cx="28584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Text Box 15"/>
          <p:cNvSpPr/>
          <p:nvPr/>
        </p:nvSpPr>
        <p:spPr>
          <a:xfrm>
            <a:off x="4506840" y="390600"/>
            <a:ext cx="284400" cy="28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Text Box 16"/>
          <p:cNvSpPr/>
          <p:nvPr/>
        </p:nvSpPr>
        <p:spPr>
          <a:xfrm>
            <a:off x="4521240" y="2639880"/>
            <a:ext cx="284040" cy="28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Text Box 17"/>
          <p:cNvSpPr/>
          <p:nvPr/>
        </p:nvSpPr>
        <p:spPr>
          <a:xfrm>
            <a:off x="4548240" y="4876920"/>
            <a:ext cx="28404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Rectangle 5"/>
          <p:cNvSpPr/>
          <p:nvPr/>
        </p:nvSpPr>
        <p:spPr>
          <a:xfrm>
            <a:off x="0" y="369108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18" name="Object 4"/>
          <p:cNvGraphicFramePr/>
          <p:nvPr/>
        </p:nvGraphicFramePr>
        <p:xfrm>
          <a:off x="196920" y="4970520"/>
          <a:ext cx="4002120" cy="26924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19" name="Object 4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96920" y="4970520"/>
                    <a:ext cx="4002120" cy="2692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20" name="Rectangle 7"/>
          <p:cNvSpPr/>
          <p:nvPr/>
        </p:nvSpPr>
        <p:spPr>
          <a:xfrm>
            <a:off x="0" y="374796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21" name="Object 6"/>
          <p:cNvGraphicFramePr/>
          <p:nvPr/>
        </p:nvGraphicFramePr>
        <p:xfrm>
          <a:off x="210960" y="2746440"/>
          <a:ext cx="3668760" cy="223200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122" name="Object 6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210960" y="2746440"/>
                    <a:ext cx="3668760" cy="2232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23" name="Rectangle 9"/>
          <p:cNvSpPr/>
          <p:nvPr/>
        </p:nvSpPr>
        <p:spPr>
          <a:xfrm>
            <a:off x="0" y="363852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24" name="Object 8"/>
          <p:cNvGraphicFramePr/>
          <p:nvPr/>
        </p:nvGraphicFramePr>
        <p:xfrm>
          <a:off x="208080" y="455760"/>
          <a:ext cx="3673440" cy="223344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125" name="Object 8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208080" y="455760"/>
                    <a:ext cx="3673440" cy="2233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26" name="Text Box 12"/>
          <p:cNvSpPr/>
          <p:nvPr/>
        </p:nvSpPr>
        <p:spPr>
          <a:xfrm>
            <a:off x="2687760" y="692280"/>
            <a:ext cx="28548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Text Box 13"/>
          <p:cNvSpPr/>
          <p:nvPr/>
        </p:nvSpPr>
        <p:spPr>
          <a:xfrm>
            <a:off x="2687760" y="5270400"/>
            <a:ext cx="285480" cy="28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Text Box 14"/>
          <p:cNvSpPr/>
          <p:nvPr/>
        </p:nvSpPr>
        <p:spPr>
          <a:xfrm>
            <a:off x="2678040" y="2936880"/>
            <a:ext cx="285840" cy="28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Text Box 15"/>
          <p:cNvSpPr/>
          <p:nvPr/>
        </p:nvSpPr>
        <p:spPr>
          <a:xfrm>
            <a:off x="82440" y="7728120"/>
            <a:ext cx="6650280" cy="1919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5.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Interactions between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. sambucinum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and biocontrol agents on NA+1.104 M NaCl: (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 adial extension of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. sambucinum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on the side adjacent to the biocontrol agent (dotted lines indicate the distance between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. sambucinum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and biocontrol agent at the time of inoculation); (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 extent of colony of biocontrol agent beyond the initial zone of inoculation (over time), on the side adjacent to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. sambucinum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; (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 distance between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. sambucinum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and biocontrol agent over time.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. sambucinum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control (</a:t>
            </a:r>
            <a:r>
              <a:rPr b="0" lang="en-GB" sz="1200" spc="-1" strike="noStrike">
                <a:solidFill>
                  <a:srgbClr val="000000"/>
                </a:solidFill>
                <a:latin typeface="Wingdings 2"/>
                <a:ea typeface="Wingdings 2"/>
              </a:rPr>
              <a:t>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, JC12GB189 (</a:t>
            </a:r>
            <a:r>
              <a:rPr b="0" lang="en-GB" sz="1200" spc="-1" strike="noStrike">
                <a:solidFill>
                  <a:srgbClr val="000000"/>
                </a:solidFill>
                <a:latin typeface="Wingdings 2"/>
                <a:ea typeface="Wingdings 2"/>
              </a:rPr>
              <a:t>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, JC12GB191 (</a:t>
            </a:r>
            <a:r>
              <a:rPr b="0" lang="en-US" sz="1200" spc="-1" strike="noStrike">
                <a:solidFill>
                  <a:srgbClr val="000000"/>
                </a:solidFill>
                <a:latin typeface="Wingdings 2"/>
                <a:ea typeface="Wingdings 2"/>
              </a:rPr>
              <a:t>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, JC12GB196 (</a:t>
            </a:r>
            <a:r>
              <a:rPr b="0" lang="en-GB" sz="1200" spc="-1" strike="noStrike">
                <a:solidFill>
                  <a:srgbClr val="000000"/>
                </a:solidFill>
                <a:latin typeface="Wingdings 2"/>
                <a:ea typeface="Wingdings 2"/>
              </a:rPr>
              <a:t>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, JC12GB197 (</a:t>
            </a:r>
            <a:r>
              <a:rPr b="0" lang="en-US" sz="1200" spc="-1" strike="noStrike">
                <a:solidFill>
                  <a:srgbClr val="000000"/>
                </a:solidFill>
                <a:latin typeface="Wingdings 2"/>
                <a:ea typeface="Wingdings 2"/>
              </a:rPr>
              <a:t>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, JC12GB190 (</a:t>
            </a:r>
            <a:r>
              <a:rPr b="0" lang="en-GB" sz="1200" spc="-1" strike="noStrike">
                <a:solidFill>
                  <a:srgbClr val="000000"/>
                </a:solidFill>
                <a:latin typeface="Wingdings 2"/>
                <a:ea typeface="Wingdings 2"/>
              </a:rPr>
              <a:t>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. Upon inoculation of NA+1.104 M NaCl,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. sambucinum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and biocontrol agents were placed 13-mm apart. Error bars indicate ± standard error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0" name="Object 46"/>
          <p:cNvGraphicFramePr/>
          <p:nvPr/>
        </p:nvGraphicFramePr>
        <p:xfrm>
          <a:off x="525600" y="2430360"/>
          <a:ext cx="3117600" cy="21193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31" name="Object 46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525600" y="2430360"/>
                    <a:ext cx="3117600" cy="2119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32" name="Object 47"/>
          <p:cNvGraphicFramePr/>
          <p:nvPr/>
        </p:nvGraphicFramePr>
        <p:xfrm>
          <a:off x="3639960" y="262080"/>
          <a:ext cx="3132360" cy="212400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133" name="Object 47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639960" y="262080"/>
                    <a:ext cx="3132360" cy="2124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34" name="Object 48"/>
          <p:cNvGraphicFramePr/>
          <p:nvPr/>
        </p:nvGraphicFramePr>
        <p:xfrm>
          <a:off x="515880" y="263520"/>
          <a:ext cx="3132360" cy="212400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135" name="Object 48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515880" y="263520"/>
                    <a:ext cx="3132360" cy="2124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36" name="Text Box 13"/>
          <p:cNvSpPr/>
          <p:nvPr/>
        </p:nvSpPr>
        <p:spPr>
          <a:xfrm>
            <a:off x="2730600" y="473040"/>
            <a:ext cx="285480" cy="28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Text Box 14"/>
          <p:cNvSpPr/>
          <p:nvPr/>
        </p:nvSpPr>
        <p:spPr>
          <a:xfrm>
            <a:off x="2711520" y="2612880"/>
            <a:ext cx="285840" cy="28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38" name="Object 49"/>
          <p:cNvGraphicFramePr/>
          <p:nvPr/>
        </p:nvGraphicFramePr>
        <p:xfrm>
          <a:off x="3633840" y="2422440"/>
          <a:ext cx="3132000" cy="212400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139" name="Object 49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3633840" y="2422440"/>
                    <a:ext cx="3132000" cy="2124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40" name="Text Box 5"/>
          <p:cNvSpPr/>
          <p:nvPr/>
        </p:nvSpPr>
        <p:spPr>
          <a:xfrm>
            <a:off x="5923080" y="2624040"/>
            <a:ext cx="285480" cy="28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Text Box 6"/>
          <p:cNvSpPr/>
          <p:nvPr/>
        </p:nvSpPr>
        <p:spPr>
          <a:xfrm>
            <a:off x="5956200" y="490680"/>
            <a:ext cx="28440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Text Box 20"/>
          <p:cNvSpPr/>
          <p:nvPr/>
        </p:nvSpPr>
        <p:spPr>
          <a:xfrm>
            <a:off x="927000" y="4503600"/>
            <a:ext cx="2314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Calibri"/>
                <a:ea typeface="Arial"/>
              </a:rPr>
              <a:t>Water activity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Text Box 20"/>
          <p:cNvSpPr/>
          <p:nvPr/>
        </p:nvSpPr>
        <p:spPr>
          <a:xfrm>
            <a:off x="4038480" y="4484520"/>
            <a:ext cx="2276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Calibri"/>
                <a:ea typeface="Arial"/>
              </a:rPr>
              <a:t>Water activity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Text Box 30"/>
          <p:cNvSpPr/>
          <p:nvPr/>
        </p:nvSpPr>
        <p:spPr>
          <a:xfrm>
            <a:off x="58680" y="5464080"/>
            <a:ext cx="6710400" cy="1532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6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Radial growth-rate of (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. coeruleum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, (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. sambucinum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, (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. infestans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0LD3 and (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. infestans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0D2_5 over a range of water-activity values. Pathogens were cultured on NA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usarium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pp.;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or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 or CA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. infestans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isolates;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or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 without added solutes (control; 0.998 water activity), and with proline (</a:t>
            </a:r>
            <a:r>
              <a:rPr b="0" lang="en-US" sz="1200" spc="-1" strike="noStrike">
                <a:solidFill>
                  <a:srgbClr val="000000"/>
                </a:solidFill>
                <a:latin typeface="Wingdings 3"/>
                <a:ea typeface="Wingdings 3"/>
              </a:rPr>
              <a:t>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, glycerol (</a:t>
            </a:r>
            <a:r>
              <a:rPr b="0" lang="en-US" sz="1200" spc="-1" strike="noStrike">
                <a:solidFill>
                  <a:srgbClr val="000000"/>
                </a:solidFill>
                <a:latin typeface="Wingdings 2"/>
                <a:ea typeface="Wingdings 2"/>
              </a:rPr>
              <a:t>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, sucrose (</a:t>
            </a:r>
            <a:r>
              <a:rPr b="0" lang="en-US" sz="1200" spc="-1" strike="noStrike">
                <a:solidFill>
                  <a:srgbClr val="000000"/>
                </a:solidFill>
                <a:latin typeface="Wingdings 2"/>
                <a:ea typeface="Wingdings 2"/>
              </a:rPr>
              <a:t>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 or NaCl (</a:t>
            </a:r>
            <a:r>
              <a:rPr b="0" lang="en-US" sz="1200" spc="-1" strike="noStrike">
                <a:solidFill>
                  <a:srgbClr val="000000"/>
                </a:solidFill>
                <a:latin typeface="Wingdings 2"/>
                <a:ea typeface="Wingdings 2"/>
              </a:rPr>
              <a:t>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 over a range of concentrations. Error bars indicate ± standard error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Text Box 20"/>
          <p:cNvSpPr/>
          <p:nvPr/>
        </p:nvSpPr>
        <p:spPr>
          <a:xfrm rot="16200000">
            <a:off x="-486720" y="1174320"/>
            <a:ext cx="19051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Calibri"/>
                <a:ea typeface="Arial"/>
              </a:rPr>
              <a:t>Radial growth rate (mm d</a:t>
            </a:r>
            <a:r>
              <a:rPr b="0" lang="en-GB" sz="1100" spc="-1" strike="noStrike" baseline="30000">
                <a:solidFill>
                  <a:srgbClr val="000000"/>
                </a:solidFill>
                <a:latin typeface="Calibri"/>
                <a:ea typeface="Arial"/>
              </a:rPr>
              <a:t>-1</a:t>
            </a:r>
            <a:r>
              <a:rPr b="0" lang="en-GB" sz="1100" spc="-1" strike="noStrike">
                <a:solidFill>
                  <a:srgbClr val="000000"/>
                </a:solidFill>
                <a:latin typeface="Calibri"/>
                <a:ea typeface="Arial"/>
              </a:rPr>
              <a:t>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Text Box 20"/>
          <p:cNvSpPr/>
          <p:nvPr/>
        </p:nvSpPr>
        <p:spPr>
          <a:xfrm rot="16200000">
            <a:off x="-486720" y="3326400"/>
            <a:ext cx="19047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Calibri"/>
                <a:ea typeface="Arial"/>
              </a:rPr>
              <a:t>Radial growth rate (mm d</a:t>
            </a:r>
            <a:r>
              <a:rPr b="0" lang="en-GB" sz="1100" spc="-1" strike="noStrike" baseline="30000">
                <a:solidFill>
                  <a:srgbClr val="000000"/>
                </a:solidFill>
                <a:latin typeface="Calibri"/>
                <a:ea typeface="Arial"/>
              </a:rPr>
              <a:t>-1</a:t>
            </a:r>
            <a:r>
              <a:rPr b="0" lang="en-GB" sz="1100" spc="-1" strike="noStrike">
                <a:solidFill>
                  <a:srgbClr val="000000"/>
                </a:solidFill>
                <a:latin typeface="Calibri"/>
                <a:ea typeface="Arial"/>
              </a:rPr>
              <a:t>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Rectangle 4"/>
          <p:cNvSpPr/>
          <p:nvPr/>
        </p:nvSpPr>
        <p:spPr>
          <a:xfrm>
            <a:off x="0" y="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48" name="Object 3"/>
          <p:cNvGraphicFramePr/>
          <p:nvPr/>
        </p:nvGraphicFramePr>
        <p:xfrm>
          <a:off x="571680" y="130320"/>
          <a:ext cx="3352680" cy="23716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49" name="Object 3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571680" y="130320"/>
                    <a:ext cx="3352680" cy="2371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50" name="Rectangle 6"/>
          <p:cNvSpPr/>
          <p:nvPr/>
        </p:nvSpPr>
        <p:spPr>
          <a:xfrm>
            <a:off x="0" y="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51" name="Object 5"/>
          <p:cNvGraphicFramePr/>
          <p:nvPr/>
        </p:nvGraphicFramePr>
        <p:xfrm>
          <a:off x="3392640" y="130320"/>
          <a:ext cx="3352680" cy="237168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152" name="Object 5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392640" y="130320"/>
                    <a:ext cx="3352680" cy="2371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53" name="Rectangle 9"/>
          <p:cNvSpPr/>
          <p:nvPr/>
        </p:nvSpPr>
        <p:spPr>
          <a:xfrm>
            <a:off x="0" y="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Rectangle 11"/>
          <p:cNvSpPr/>
          <p:nvPr/>
        </p:nvSpPr>
        <p:spPr>
          <a:xfrm>
            <a:off x="0" y="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55" name="Object 10"/>
          <p:cNvGraphicFramePr/>
          <p:nvPr/>
        </p:nvGraphicFramePr>
        <p:xfrm>
          <a:off x="571680" y="2305080"/>
          <a:ext cx="3352680" cy="237168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156" name="Object 10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571680" y="2305080"/>
                    <a:ext cx="3352680" cy="2371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57" name="Rectangle 13"/>
          <p:cNvSpPr/>
          <p:nvPr/>
        </p:nvSpPr>
        <p:spPr>
          <a:xfrm>
            <a:off x="0" y="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Rectangle 15"/>
          <p:cNvSpPr/>
          <p:nvPr/>
        </p:nvSpPr>
        <p:spPr>
          <a:xfrm>
            <a:off x="0" y="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59" name="Object 14"/>
          <p:cNvGraphicFramePr/>
          <p:nvPr/>
        </p:nvGraphicFramePr>
        <p:xfrm>
          <a:off x="3400560" y="2276640"/>
          <a:ext cx="3365280" cy="240156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160" name="Object 14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3400560" y="2276640"/>
                    <a:ext cx="3365280" cy="2401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61" name="Rectangle 18"/>
          <p:cNvSpPr/>
          <p:nvPr/>
        </p:nvSpPr>
        <p:spPr>
          <a:xfrm>
            <a:off x="0" y="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62" name="Object 17"/>
          <p:cNvGraphicFramePr/>
          <p:nvPr/>
        </p:nvGraphicFramePr>
        <p:xfrm>
          <a:off x="571680" y="4602240"/>
          <a:ext cx="3352680" cy="237168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163" name="Object 17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571680" y="4602240"/>
                    <a:ext cx="3352680" cy="2371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64" name="Rectangle 20"/>
          <p:cNvSpPr/>
          <p:nvPr/>
        </p:nvSpPr>
        <p:spPr>
          <a:xfrm>
            <a:off x="0" y="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65" name="Object 19"/>
          <p:cNvGraphicFramePr/>
          <p:nvPr/>
        </p:nvGraphicFramePr>
        <p:xfrm>
          <a:off x="3373560" y="4602240"/>
          <a:ext cx="3352680" cy="237168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166" name="Object 19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3373560" y="4602240"/>
                    <a:ext cx="3352680" cy="2371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67" name="Text Box 12"/>
          <p:cNvSpPr/>
          <p:nvPr/>
        </p:nvSpPr>
        <p:spPr>
          <a:xfrm>
            <a:off x="1273320" y="374760"/>
            <a:ext cx="25704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Text Box 13"/>
          <p:cNvSpPr/>
          <p:nvPr/>
        </p:nvSpPr>
        <p:spPr>
          <a:xfrm>
            <a:off x="1254240" y="4824360"/>
            <a:ext cx="285480" cy="28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Text Box 14"/>
          <p:cNvSpPr/>
          <p:nvPr/>
        </p:nvSpPr>
        <p:spPr>
          <a:xfrm>
            <a:off x="1255680" y="2546280"/>
            <a:ext cx="285840" cy="28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Text Box 15"/>
          <p:cNvSpPr/>
          <p:nvPr/>
        </p:nvSpPr>
        <p:spPr>
          <a:xfrm>
            <a:off x="4087800" y="374760"/>
            <a:ext cx="28404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Text Box 16"/>
          <p:cNvSpPr/>
          <p:nvPr/>
        </p:nvSpPr>
        <p:spPr>
          <a:xfrm>
            <a:off x="4051440" y="2548080"/>
            <a:ext cx="28404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" name="Text Box 17"/>
          <p:cNvSpPr/>
          <p:nvPr/>
        </p:nvSpPr>
        <p:spPr>
          <a:xfrm>
            <a:off x="4071960" y="4856040"/>
            <a:ext cx="284040" cy="28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TextBox 17"/>
          <p:cNvSpPr/>
          <p:nvPr/>
        </p:nvSpPr>
        <p:spPr>
          <a:xfrm rot="16200000">
            <a:off x="-404280" y="1018800"/>
            <a:ext cx="177156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Radial extension of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F. coeruleum 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(mm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TextBox 17"/>
          <p:cNvSpPr/>
          <p:nvPr/>
        </p:nvSpPr>
        <p:spPr>
          <a:xfrm rot="16200000">
            <a:off x="-395640" y="5496480"/>
            <a:ext cx="176976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Radial extension of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F. coeruleum 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(mm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TextBox 17"/>
          <p:cNvSpPr/>
          <p:nvPr/>
        </p:nvSpPr>
        <p:spPr>
          <a:xfrm rot="16200000">
            <a:off x="-396360" y="3203280"/>
            <a:ext cx="177156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Radial extension of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F. coeruleum 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(mm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" name="TextBox 17"/>
          <p:cNvSpPr/>
          <p:nvPr/>
        </p:nvSpPr>
        <p:spPr>
          <a:xfrm>
            <a:off x="963720" y="6929280"/>
            <a:ext cx="2495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Incubation time (d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" name="TextBox 17"/>
          <p:cNvSpPr/>
          <p:nvPr/>
        </p:nvSpPr>
        <p:spPr>
          <a:xfrm>
            <a:off x="3773520" y="6899400"/>
            <a:ext cx="2495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Incubation time (d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" name="Text Box 30"/>
          <p:cNvSpPr/>
          <p:nvPr/>
        </p:nvSpPr>
        <p:spPr>
          <a:xfrm>
            <a:off x="47520" y="7553160"/>
            <a:ext cx="6697800" cy="154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7.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Radial-extension of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. coeruleum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over a range of urea concentrations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(0 mM: </a:t>
            </a:r>
            <a:r>
              <a:rPr b="0" lang="en-US" sz="1200" spc="-1" strike="noStrike">
                <a:solidFill>
                  <a:srgbClr val="000000"/>
                </a:solidFill>
                <a:latin typeface="Wingdings 2"/>
                <a:ea typeface="Wingdings 2"/>
              </a:rPr>
              <a:t>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; 50 mM: </a:t>
            </a:r>
            <a:r>
              <a:rPr b="0" lang="en-US" sz="1200" spc="-1" strike="noStrike">
                <a:solidFill>
                  <a:srgbClr val="000000"/>
                </a:solidFill>
                <a:latin typeface="Wingdings 2"/>
                <a:ea typeface="Wingdings 2"/>
              </a:rPr>
              <a:t>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;  100 mM: </a:t>
            </a:r>
            <a:r>
              <a:rPr b="0" lang="en-US" sz="1200" spc="-1" strike="noStrike">
                <a:solidFill>
                  <a:srgbClr val="000000"/>
                </a:solidFill>
                <a:latin typeface="Wingdings 3"/>
                <a:ea typeface="Wingdings 3"/>
              </a:rPr>
              <a:t>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; 150 mM: </a:t>
            </a:r>
            <a:r>
              <a:rPr b="0" lang="en-US" sz="1200" spc="-1" strike="noStrike">
                <a:solidFill>
                  <a:srgbClr val="000000"/>
                </a:solidFill>
                <a:latin typeface="Wingdings 2"/>
                <a:ea typeface="Wingdings 2"/>
              </a:rPr>
              <a:t>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; 200 mM: </a:t>
            </a:r>
            <a:r>
              <a:rPr b="0" lang="en-US" sz="1200" spc="-1" strike="noStrike">
                <a:solidFill>
                  <a:srgbClr val="000000"/>
                </a:solidFill>
                <a:latin typeface="Wingdings 2"/>
                <a:ea typeface="Wingdings 2"/>
              </a:rPr>
              <a:t>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; 250 mM: </a:t>
            </a:r>
            <a:r>
              <a:rPr b="0" lang="en-US" sz="1200" spc="-1" strike="noStrike">
                <a:solidFill>
                  <a:srgbClr val="000000"/>
                </a:solidFill>
                <a:latin typeface="Wingdings 3"/>
                <a:ea typeface="Wingdings 3"/>
              </a:rPr>
              <a:t>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 and temperatures (5.2°C: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;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1.6°C: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; 13.4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°C: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;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9.8°C: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;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3.2°C: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;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30.2°C: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. Data series where no growth had occurred by 28 days do not appear on the graphs. Error bars indicate ± standard error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79" name="Object 4"/>
          <p:cNvGraphicFramePr/>
          <p:nvPr/>
        </p:nvGraphicFramePr>
        <p:xfrm>
          <a:off x="28440" y="1793880"/>
          <a:ext cx="3443400" cy="49975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80" name="Object 4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8440" y="1793880"/>
                    <a:ext cx="3443400" cy="4997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81" name="Object 5"/>
          <p:cNvGraphicFramePr/>
          <p:nvPr/>
        </p:nvGraphicFramePr>
        <p:xfrm>
          <a:off x="0" y="-592200"/>
          <a:ext cx="3341520" cy="368928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182" name="Object 5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0" y="-592200"/>
                    <a:ext cx="3341520" cy="3689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83" name="Text Box 6"/>
          <p:cNvSpPr/>
          <p:nvPr/>
        </p:nvSpPr>
        <p:spPr>
          <a:xfrm>
            <a:off x="2577960" y="136440"/>
            <a:ext cx="403200" cy="298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4" name="Text Box 7"/>
          <p:cNvSpPr/>
          <p:nvPr/>
        </p:nvSpPr>
        <p:spPr>
          <a:xfrm>
            <a:off x="2584440" y="2552760"/>
            <a:ext cx="309600" cy="296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85" name="Object 8"/>
          <p:cNvGraphicFramePr/>
          <p:nvPr/>
        </p:nvGraphicFramePr>
        <p:xfrm>
          <a:off x="3505320" y="-57240"/>
          <a:ext cx="2949480" cy="255744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186" name="Object 8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3505320" y="-57240"/>
                    <a:ext cx="2949480" cy="2557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87" name="Object 9"/>
          <p:cNvGraphicFramePr/>
          <p:nvPr/>
        </p:nvGraphicFramePr>
        <p:xfrm>
          <a:off x="3500280" y="2308320"/>
          <a:ext cx="3022920" cy="429552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188" name="Object 9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3500280" y="2308320"/>
                    <a:ext cx="3022920" cy="4295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89" name="Text Box 10"/>
          <p:cNvSpPr/>
          <p:nvPr/>
        </p:nvSpPr>
        <p:spPr>
          <a:xfrm>
            <a:off x="5692680" y="160200"/>
            <a:ext cx="308160" cy="297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0" name="Text Box 11"/>
          <p:cNvSpPr/>
          <p:nvPr/>
        </p:nvSpPr>
        <p:spPr>
          <a:xfrm>
            <a:off x="5694480" y="2560680"/>
            <a:ext cx="309600" cy="298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1" name="Text Box 12"/>
          <p:cNvSpPr/>
          <p:nvPr/>
        </p:nvSpPr>
        <p:spPr>
          <a:xfrm>
            <a:off x="95400" y="6927840"/>
            <a:ext cx="669744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8.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Radial growth-rates of potato pathogens on various media at 20°C: (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. coeruleum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, (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. sambucinum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, (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P. Infestans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10LD3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and (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P. infestans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10D2_5. Error bars indicate standard error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2" name="Text Box 12"/>
          <p:cNvSpPr/>
          <p:nvPr/>
        </p:nvSpPr>
        <p:spPr>
          <a:xfrm rot="16200000">
            <a:off x="-797400" y="1099080"/>
            <a:ext cx="214848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Radial growth-rate (mm d</a:t>
            </a:r>
            <a:r>
              <a:rPr b="1" lang="en-GB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1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3" name="Text Box 12"/>
          <p:cNvSpPr/>
          <p:nvPr/>
        </p:nvSpPr>
        <p:spPr>
          <a:xfrm rot="16200000">
            <a:off x="-791280" y="3457440"/>
            <a:ext cx="214848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Radial growth-rate (mm d</a:t>
            </a:r>
            <a:r>
              <a:rPr b="1" lang="en-GB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1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4" name="Text Box 12"/>
          <p:cNvSpPr/>
          <p:nvPr/>
        </p:nvSpPr>
        <p:spPr>
          <a:xfrm>
            <a:off x="1683000" y="6211800"/>
            <a:ext cx="75672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Mediu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5" name="Text Box 12"/>
          <p:cNvSpPr/>
          <p:nvPr/>
        </p:nvSpPr>
        <p:spPr>
          <a:xfrm>
            <a:off x="4665960" y="6219720"/>
            <a:ext cx="75672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Mediu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4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2-11T10:48:59Z</dcterms:created>
  <dc:creator>Jonathan Cray</dc:creator>
  <dc:description/>
  <dc:language>en-US</dc:language>
  <cp:lastModifiedBy>Jim</cp:lastModifiedBy>
  <cp:lastPrinted>2014-12-11T10:51:48Z</cp:lastPrinted>
  <dcterms:modified xsi:type="dcterms:W3CDTF">2016-01-12T22:41:32Z</dcterms:modified>
  <cp:revision>59</cp:revision>
  <dc:subject/>
  <dc:title>PowerPoint Presentation</dc:title>
</cp:coreProperties>
</file>